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336" y="-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/>
              <a:t>uORF1</a:t>
            </a:r>
            <a:endParaRPr lang="zh-CN" sz="800"/>
          </a:p>
        </c:rich>
      </c:tx>
      <c:layout>
        <c:manualLayout>
          <c:xMode val="edge"/>
          <c:yMode val="edge"/>
          <c:x val="0.41668126619705592"/>
          <c:y val="8.3436302119261854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销售额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</c:spPr>
          <c:dPt>
            <c:idx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449-4813-BCF5-4E2ADC818E32}"/>
              </c:ext>
            </c:extLst>
          </c:dPt>
          <c:dPt>
            <c:idx val="1"/>
            <c:bubble3D val="0"/>
            <c:spPr>
              <a:solidFill>
                <a:schemeClr val="bg2">
                  <a:lumMod val="9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163B-4875-B55F-490CEAF42629}"/>
              </c:ext>
            </c:extLst>
          </c:dPt>
          <c:cat>
            <c:strRef>
              <c:f>Sheet1!$A$2:$A$3</c:f>
              <c:strCache>
                <c:ptCount val="2"/>
                <c:pt idx="0">
                  <c:v>Col-0 type</c:v>
                </c:pt>
                <c:pt idx="1">
                  <c:v>Other type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96.57</c:v>
                </c:pt>
                <c:pt idx="1">
                  <c:v>3.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63B-4875-B55F-490CEAF426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488916261136636"/>
          <c:y val="0.81486389168947138"/>
          <c:w val="0.46166410388756296"/>
          <c:h val="9.528162910516967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uORF2</a:t>
            </a:r>
            <a:endParaRPr lang="zh-CN" sz="800" dirty="0"/>
          </a:p>
        </c:rich>
      </c:tx>
      <c:layout>
        <c:manualLayout>
          <c:xMode val="edge"/>
          <c:yMode val="edge"/>
          <c:x val="0.44744361648958808"/>
          <c:y val="7.701812503316479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销售额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</c:spPr>
          <c:dPt>
            <c:idx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068-4725-9B72-C780DC877DDC}"/>
              </c:ext>
            </c:extLst>
          </c:dPt>
          <c:dPt>
            <c:idx val="1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068-4725-9B72-C780DC877DDC}"/>
              </c:ext>
            </c:extLst>
          </c:dPt>
          <c:dPt>
            <c:idx val="2"/>
            <c:bubble3D val="0"/>
            <c:spPr>
              <a:solidFill>
                <a:schemeClr val="bg2">
                  <a:lumMod val="9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6-0068-4725-9B72-C780DC877DDC}"/>
              </c:ext>
            </c:extLst>
          </c:dPt>
          <c:cat>
            <c:strRef>
              <c:f>Sheet1!$A$2:$A$4</c:f>
              <c:strCache>
                <c:ptCount val="3"/>
                <c:pt idx="0">
                  <c:v>Col-0 type</c:v>
                </c:pt>
                <c:pt idx="1">
                  <c:v>Ws-2 type</c:v>
                </c:pt>
                <c:pt idx="2">
                  <c:v>Other type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42.96</c:v>
                </c:pt>
                <c:pt idx="1">
                  <c:v>56.78</c:v>
                </c:pt>
                <c:pt idx="2">
                  <c:v>0.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0068-4725-9B72-C780DC877D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488916261136636"/>
          <c:y val="0.81486389168947138"/>
          <c:w val="0.46166410388756296"/>
          <c:h val="9.528162910516967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4C5C0F-96B2-4E8C-A80F-CC88177DD63E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B22853-E630-4A0F-9683-5DB4CEB6CE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2603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5BFDF0-667E-481A-BF9B-EFCAB62C7082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340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816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267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537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498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245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92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218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925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001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430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12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9FB45F-CF21-41F6-9D2F-EA10EBD4083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EB0E2-937D-420A-95DC-4B736B5ED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589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5" Type="http://schemas.openxmlformats.org/officeDocument/2006/relationships/image" Target="../media/image2.tiff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Tif"/><Relationship Id="rId4" Type="http://schemas.openxmlformats.org/officeDocument/2006/relationships/image" Target="../media/image4.Ti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组合 43">
            <a:extLst>
              <a:ext uri="{FF2B5EF4-FFF2-40B4-BE49-F238E27FC236}">
                <a16:creationId xmlns:a16="http://schemas.microsoft.com/office/drawing/2014/main" xmlns="" id="{A393EE9A-A889-48E1-954B-D3F576C69285}"/>
              </a:ext>
            </a:extLst>
          </p:cNvPr>
          <p:cNvGrpSpPr/>
          <p:nvPr/>
        </p:nvGrpSpPr>
        <p:grpSpPr>
          <a:xfrm>
            <a:off x="916556" y="1607654"/>
            <a:ext cx="1794968" cy="1649868"/>
            <a:chOff x="3967529" y="979031"/>
            <a:chExt cx="3549279" cy="2446773"/>
          </a:xfrm>
        </p:grpSpPr>
        <p:pic>
          <p:nvPicPr>
            <p:cNvPr id="12" name="图片 11" descr="GFP1   gfpluc1 45 gfp luc45">
              <a:extLst>
                <a:ext uri="{FF2B5EF4-FFF2-40B4-BE49-F238E27FC236}">
                  <a16:creationId xmlns:a16="http://schemas.microsoft.com/office/drawing/2014/main" xmlns="" id="{D630098D-05BE-4B07-A484-7BAA5739D040}"/>
                </a:ext>
              </a:extLst>
            </p:cNvPr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45110" t="10793"/>
            <a:stretch/>
          </p:blipFill>
          <p:spPr>
            <a:xfrm>
              <a:off x="4765202" y="979031"/>
              <a:ext cx="1418842" cy="2446773"/>
            </a:xfrm>
            <a:prstGeom prst="rect">
              <a:avLst/>
            </a:prstGeom>
          </p:spPr>
        </p:pic>
        <p:sp>
          <p:nvSpPr>
            <p:cNvPr id="14" name="椭圆 13">
              <a:extLst>
                <a:ext uri="{FF2B5EF4-FFF2-40B4-BE49-F238E27FC236}">
                  <a16:creationId xmlns:a16="http://schemas.microsoft.com/office/drawing/2014/main" xmlns="" id="{FBFF7754-5192-4D05-ABDF-97A43BF2EA6E}"/>
                </a:ext>
              </a:extLst>
            </p:cNvPr>
            <p:cNvSpPr/>
            <p:nvPr/>
          </p:nvSpPr>
          <p:spPr>
            <a:xfrm>
              <a:off x="5151117" y="1035172"/>
              <a:ext cx="792207" cy="803670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椭圆 14">
              <a:extLst>
                <a:ext uri="{FF2B5EF4-FFF2-40B4-BE49-F238E27FC236}">
                  <a16:creationId xmlns:a16="http://schemas.microsoft.com/office/drawing/2014/main" xmlns="" id="{2311F429-5B6B-438C-AC5B-7AFCE5274D86}"/>
                </a:ext>
              </a:extLst>
            </p:cNvPr>
            <p:cNvSpPr/>
            <p:nvPr/>
          </p:nvSpPr>
          <p:spPr>
            <a:xfrm>
              <a:off x="5151754" y="2371226"/>
              <a:ext cx="792207" cy="803670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 descr="gfpluc1 45 gfp luc45">
              <a:extLst>
                <a:ext uri="{FF2B5EF4-FFF2-40B4-BE49-F238E27FC236}">
                  <a16:creationId xmlns:a16="http://schemas.microsoft.com/office/drawing/2014/main" xmlns="" id="{4D0B1997-3D49-4ECF-A74E-472EC78222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lum bright="24000" contrast="96000"/>
            </a:blip>
            <a:srcRect l="50958" t="-306" r="-175" b="10178"/>
            <a:stretch/>
          </p:blipFill>
          <p:spPr>
            <a:xfrm>
              <a:off x="6259955" y="979031"/>
              <a:ext cx="1256853" cy="2446773"/>
            </a:xfrm>
            <a:prstGeom prst="rect">
              <a:avLst/>
            </a:prstGeom>
          </p:spPr>
        </p:pic>
        <p:sp>
          <p:nvSpPr>
            <p:cNvPr id="19" name="椭圆 18">
              <a:extLst>
                <a:ext uri="{FF2B5EF4-FFF2-40B4-BE49-F238E27FC236}">
                  <a16:creationId xmlns:a16="http://schemas.microsoft.com/office/drawing/2014/main" xmlns="" id="{193A6D74-4390-490E-ADD9-B8DC6624479F}"/>
                </a:ext>
              </a:extLst>
            </p:cNvPr>
            <p:cNvSpPr/>
            <p:nvPr/>
          </p:nvSpPr>
          <p:spPr>
            <a:xfrm>
              <a:off x="6444042" y="2371226"/>
              <a:ext cx="792207" cy="803670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椭圆 19">
              <a:extLst>
                <a:ext uri="{FF2B5EF4-FFF2-40B4-BE49-F238E27FC236}">
                  <a16:creationId xmlns:a16="http://schemas.microsoft.com/office/drawing/2014/main" xmlns="" id="{4AD827C1-DA60-4147-B214-E4C8876E4924}"/>
                </a:ext>
              </a:extLst>
            </p:cNvPr>
            <p:cNvSpPr/>
            <p:nvPr/>
          </p:nvSpPr>
          <p:spPr>
            <a:xfrm>
              <a:off x="6444042" y="1035172"/>
              <a:ext cx="792207" cy="803670"/>
            </a:xfrm>
            <a:prstGeom prst="ellipse">
              <a:avLst/>
            </a:prstGeom>
            <a:noFill/>
            <a:ln w="12700" cmpd="sng">
              <a:solidFill>
                <a:schemeClr val="bg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xmlns="" id="{B767527E-4289-4C03-9C54-FAB678EBD30A}"/>
                </a:ext>
              </a:extLst>
            </p:cNvPr>
            <p:cNvSpPr txBox="1"/>
            <p:nvPr/>
          </p:nvSpPr>
          <p:spPr>
            <a:xfrm>
              <a:off x="3967529" y="1329286"/>
              <a:ext cx="783548" cy="319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xmlns="" id="{18BA5A0F-572F-49C6-9F9E-3EB54FB44E54}"/>
                </a:ext>
              </a:extLst>
            </p:cNvPr>
            <p:cNvSpPr txBox="1"/>
            <p:nvPr/>
          </p:nvSpPr>
          <p:spPr>
            <a:xfrm>
              <a:off x="3976842" y="2665339"/>
              <a:ext cx="770870" cy="3195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UC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830BE866-3EB8-4D90-94BB-87E8F27DA070}"/>
              </a:ext>
            </a:extLst>
          </p:cNvPr>
          <p:cNvSpPr txBox="1"/>
          <p:nvPr/>
        </p:nvSpPr>
        <p:spPr>
          <a:xfrm>
            <a:off x="1178999" y="1368600"/>
            <a:ext cx="8034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xmlns="" id="{5A5596BB-805A-417B-9018-D64A1E544C63}"/>
              </a:ext>
            </a:extLst>
          </p:cNvPr>
          <p:cNvSpPr txBox="1"/>
          <p:nvPr/>
        </p:nvSpPr>
        <p:spPr>
          <a:xfrm>
            <a:off x="1838121" y="1368600"/>
            <a:ext cx="8499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uminescenc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3B444BA7-88C8-458B-A729-91FF9039F36A}"/>
              </a:ext>
            </a:extLst>
          </p:cNvPr>
          <p:cNvSpPr/>
          <p:nvPr/>
        </p:nvSpPr>
        <p:spPr>
          <a:xfrm>
            <a:off x="51378" y="164599"/>
            <a:ext cx="6319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181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A6800819-9F8D-4A6C-9B72-D915B905F3F1}"/>
              </a:ext>
            </a:extLst>
          </p:cNvPr>
          <p:cNvSpPr/>
          <p:nvPr/>
        </p:nvSpPr>
        <p:spPr>
          <a:xfrm>
            <a:off x="51378" y="164599"/>
            <a:ext cx="6319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4614315A-C2C4-4B50-9FA5-887F77656220}"/>
              </a:ext>
            </a:extLst>
          </p:cNvPr>
          <p:cNvSpPr txBox="1"/>
          <p:nvPr/>
        </p:nvSpPr>
        <p:spPr>
          <a:xfrm>
            <a:off x="1137121" y="488893"/>
            <a:ext cx="4158615" cy="304698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>
              <a:lnSpc>
                <a:spcPct val="300000"/>
              </a:lnSpc>
            </a:pP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CTTCATATCTTAATTCTTGAACATTATTCATAATTCATCATCATCATCATCTTTTCTTCAAGTAGCTTCAACACAAGTCTATTGCCCAACTACTATCTATAGTTTAAGCATACGTATTT</a:t>
            </a:r>
            <a:r>
              <a:rPr lang="en-US" altLang="zh-CN" sz="800" dirty="0">
                <a:solidFill>
                  <a:sysClr val="windowText" lastClr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TGTTTCTTCGGTTCAATTGCACAAAACCGAATTTGGTTCGGATTCAATTCTATTATTTCGGTATTCCTACAGGTTATTTCGGTTGGATTCGGTTATTCATTCACACGGTGAGGATAATACTATCCAG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TGAAGGATAGGAATGATCTGAACGCCAAACAAAGACAATTAGTGATCAGCGAATCGCCGCCTTTTTGAGTCGTCTTGCAGCAAAGTAGATTCCGCGGCAAATCACAGAACACCAATCGGAATAATCACACAAGAACAAAACTTGTTAATCAGGAGAAGACGACAGAGAGAGAGAAGGAGAGAGATCTTC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xmlns="" id="{94023566-BE76-4762-A22D-CDD2AB52AD9E}"/>
              </a:ext>
            </a:extLst>
          </p:cNvPr>
          <p:cNvCxnSpPr>
            <a:cxnSpLocks/>
          </p:cNvCxnSpPr>
          <p:nvPr/>
        </p:nvCxnSpPr>
        <p:spPr>
          <a:xfrm>
            <a:off x="1102379" y="710469"/>
            <a:ext cx="0" cy="189145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xmlns="" id="{D9C3C522-F1C7-4FA2-BF1F-3D79245B21BB}"/>
              </a:ext>
            </a:extLst>
          </p:cNvPr>
          <p:cNvCxnSpPr>
            <a:cxnSpLocks/>
          </p:cNvCxnSpPr>
          <p:nvPr/>
        </p:nvCxnSpPr>
        <p:spPr>
          <a:xfrm>
            <a:off x="1102379" y="2829539"/>
            <a:ext cx="0" cy="150754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xmlns="" id="{FC1F3157-96B3-40FB-9DA1-B7AA68050255}"/>
              </a:ext>
            </a:extLst>
          </p:cNvPr>
          <p:cNvCxnSpPr>
            <a:cxnSpLocks/>
          </p:cNvCxnSpPr>
          <p:nvPr/>
        </p:nvCxnSpPr>
        <p:spPr>
          <a:xfrm>
            <a:off x="1102379" y="4445728"/>
            <a:ext cx="0" cy="64717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D6699305-B7A6-44BC-B07E-08433DE79B7F}"/>
              </a:ext>
            </a:extLst>
          </p:cNvPr>
          <p:cNvSpPr txBox="1"/>
          <p:nvPr/>
        </p:nvSpPr>
        <p:spPr>
          <a:xfrm>
            <a:off x="676787" y="1602184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’ UT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1D1EF7A5-44A7-4D92-96F8-0B2660EF40B1}"/>
              </a:ext>
            </a:extLst>
          </p:cNvPr>
          <p:cNvSpPr txBox="1"/>
          <p:nvPr/>
        </p:nvSpPr>
        <p:spPr>
          <a:xfrm>
            <a:off x="633306" y="3411960"/>
            <a:ext cx="5533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DS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mORF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4A26F494-9287-4BAC-B846-F752FFBD56DF}"/>
              </a:ext>
            </a:extLst>
          </p:cNvPr>
          <p:cNvSpPr txBox="1"/>
          <p:nvPr/>
        </p:nvSpPr>
        <p:spPr>
          <a:xfrm>
            <a:off x="676787" y="4675266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’ UTR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xmlns="" id="{770D1BAD-A3FC-47AB-AD57-D982F3ADBC0C}"/>
              </a:ext>
            </a:extLst>
          </p:cNvPr>
          <p:cNvCxnSpPr>
            <a:cxnSpLocks/>
          </p:cNvCxnSpPr>
          <p:nvPr/>
        </p:nvCxnSpPr>
        <p:spPr>
          <a:xfrm>
            <a:off x="3289745" y="1216423"/>
            <a:ext cx="190801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xmlns="" id="{CD95B2DC-BDFB-4724-BEDF-396B91D34467}"/>
              </a:ext>
            </a:extLst>
          </p:cNvPr>
          <p:cNvCxnSpPr>
            <a:cxnSpLocks/>
          </p:cNvCxnSpPr>
          <p:nvPr/>
        </p:nvCxnSpPr>
        <p:spPr>
          <a:xfrm>
            <a:off x="1186750" y="1587898"/>
            <a:ext cx="401101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333EFE89-4A58-41D6-89AF-D34E9B9C1735}"/>
              </a:ext>
            </a:extLst>
          </p:cNvPr>
          <p:cNvSpPr txBox="1"/>
          <p:nvPr/>
        </p:nvSpPr>
        <p:spPr>
          <a:xfrm>
            <a:off x="3131318" y="1196242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ORF1</a:t>
            </a:r>
            <a:endParaRPr lang="zh-CN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xmlns="" id="{B692F628-4054-4493-A06F-732C4AB244DE}"/>
              </a:ext>
            </a:extLst>
          </p:cNvPr>
          <p:cNvCxnSpPr>
            <a:cxnSpLocks/>
          </p:cNvCxnSpPr>
          <p:nvPr/>
        </p:nvCxnSpPr>
        <p:spPr>
          <a:xfrm>
            <a:off x="1914999" y="1959373"/>
            <a:ext cx="3282764" cy="0"/>
          </a:xfrm>
          <a:prstGeom prst="line">
            <a:avLst/>
          </a:prstGeom>
          <a:ln>
            <a:solidFill>
              <a:srgbClr val="2F559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541B14A3-D813-47E3-A6E2-4D549D63B9E9}"/>
              </a:ext>
            </a:extLst>
          </p:cNvPr>
          <p:cNvSpPr txBox="1"/>
          <p:nvPr/>
        </p:nvSpPr>
        <p:spPr>
          <a:xfrm>
            <a:off x="1756573" y="1935559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solidFill>
                  <a:srgbClr val="2F559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ORF2</a:t>
            </a:r>
            <a:endParaRPr lang="zh-CN" altLang="en-US" sz="800" dirty="0">
              <a:solidFill>
                <a:srgbClr val="2F559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xmlns="" id="{0B4C6D14-5A5C-42C0-8E2F-62A8F6351918}"/>
              </a:ext>
            </a:extLst>
          </p:cNvPr>
          <p:cNvCxnSpPr>
            <a:cxnSpLocks/>
          </p:cNvCxnSpPr>
          <p:nvPr/>
        </p:nvCxnSpPr>
        <p:spPr>
          <a:xfrm>
            <a:off x="2621477" y="1800194"/>
            <a:ext cx="450984" cy="0"/>
          </a:xfrm>
          <a:prstGeom prst="line">
            <a:avLst/>
          </a:prstGeom>
          <a:ln>
            <a:solidFill>
              <a:srgbClr val="70AD4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62B4D385-1D8D-40D2-80D2-66C8BDD130A4}"/>
              </a:ext>
            </a:extLst>
          </p:cNvPr>
          <p:cNvSpPr txBox="1"/>
          <p:nvPr/>
        </p:nvSpPr>
        <p:spPr>
          <a:xfrm>
            <a:off x="2483420" y="162874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solidFill>
                  <a:srgbClr val="70AD47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ORF3</a:t>
            </a:r>
            <a:endParaRPr lang="zh-CN" altLang="en-US" sz="800" dirty="0">
              <a:solidFill>
                <a:srgbClr val="70AD4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49B44AA8-E639-40B7-AA42-B17322237CE8}"/>
              </a:ext>
            </a:extLst>
          </p:cNvPr>
          <p:cNvSpPr txBox="1"/>
          <p:nvPr/>
        </p:nvSpPr>
        <p:spPr>
          <a:xfrm>
            <a:off x="1102378" y="387864"/>
            <a:ext cx="82907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CD11 cDN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F699D49B-6560-4B1B-8E7D-EEBEDE565A49}"/>
              </a:ext>
            </a:extLst>
          </p:cNvPr>
          <p:cNvSpPr txBox="1"/>
          <p:nvPr/>
        </p:nvSpPr>
        <p:spPr>
          <a:xfrm>
            <a:off x="936442" y="5443402"/>
            <a:ext cx="9348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8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NN</a:t>
            </a:r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C1D04779-BB9D-4D8B-9BDC-AD335EF162A5}"/>
              </a:ext>
            </a:extLst>
          </p:cNvPr>
          <p:cNvSpPr txBox="1"/>
          <p:nvPr/>
        </p:nvSpPr>
        <p:spPr>
          <a:xfrm>
            <a:off x="1734188" y="5443402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trong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8D96F95E-0EB2-4F5D-B59C-7D8C5B1BEF04}"/>
              </a:ext>
            </a:extLst>
          </p:cNvPr>
          <p:cNvSpPr txBox="1"/>
          <p:nvPr/>
        </p:nvSpPr>
        <p:spPr>
          <a:xfrm>
            <a:off x="3705504" y="5445156"/>
            <a:ext cx="6538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eak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eak Moderate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oderate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xmlns="" id="{D119F9CF-7830-4A34-9856-72B257942344}"/>
              </a:ext>
            </a:extLst>
          </p:cNvPr>
          <p:cNvSpPr txBox="1"/>
          <p:nvPr/>
        </p:nvSpPr>
        <p:spPr>
          <a:xfrm>
            <a:off x="2714052" y="5445052"/>
            <a:ext cx="59663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ORF1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ORF2</a:t>
            </a:r>
          </a:p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ORF3</a:t>
            </a:r>
          </a:p>
          <a:p>
            <a:pPr algn="ctr"/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mORF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xmlns="" id="{EC5AAA36-6906-4963-8EC3-F8BE50FCC7D6}"/>
              </a:ext>
            </a:extLst>
          </p:cNvPr>
          <p:cNvSpPr txBox="1"/>
          <p:nvPr/>
        </p:nvSpPr>
        <p:spPr>
          <a:xfrm>
            <a:off x="3224123" y="5445156"/>
            <a:ext cx="653846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UU</a:t>
            </a:r>
            <a:r>
              <a:rPr lang="en-US" altLang="zh-CN" sz="10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rgbClr val="ED7D3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endParaRPr lang="en-US" altLang="zh-CN" sz="8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AG</a:t>
            </a:r>
            <a:r>
              <a:rPr lang="en-US" altLang="zh-CN" sz="10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rgbClr val="ED7D3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</a:p>
          <a:p>
            <a:r>
              <a:rPr lang="en-US" altLang="zh-CN" sz="800" dirty="0">
                <a:solidFill>
                  <a:srgbClr val="2F5597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A</a:t>
            </a:r>
            <a:r>
              <a:rPr lang="en-US" altLang="zh-CN" sz="10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rgbClr val="ED7D3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</a:p>
          <a:p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CC</a:t>
            </a:r>
            <a:r>
              <a:rPr lang="en-US" altLang="zh-CN" sz="10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rgbClr val="ED7D3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solidFill>
                  <a:srgbClr val="2F5597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endParaRPr lang="zh-CN" altLang="en-US" sz="800" dirty="0">
              <a:solidFill>
                <a:srgbClr val="2F5597"/>
              </a:solidFill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xmlns="" id="{5FB81220-1013-4F23-B43A-BBDDED48C867}"/>
              </a:ext>
            </a:extLst>
          </p:cNvPr>
          <p:cNvSpPr txBox="1"/>
          <p:nvPr/>
        </p:nvSpPr>
        <p:spPr>
          <a:xfrm>
            <a:off x="942053" y="5597841"/>
            <a:ext cx="9284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8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)NN</a:t>
            </a:r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xmlns="" id="{7997E2FD-7FF0-4E5C-8C1A-72910B5BD676}"/>
              </a:ext>
            </a:extLst>
          </p:cNvPr>
          <p:cNvSpPr txBox="1"/>
          <p:nvPr/>
        </p:nvSpPr>
        <p:spPr>
          <a:xfrm>
            <a:off x="1086522" y="5752280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NN</a:t>
            </a:r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FC794937-A5B9-461E-987E-6DE2CD41D78D}"/>
              </a:ext>
            </a:extLst>
          </p:cNvPr>
          <p:cNvSpPr txBox="1"/>
          <p:nvPr/>
        </p:nvSpPr>
        <p:spPr>
          <a:xfrm>
            <a:off x="1092133" y="5906718"/>
            <a:ext cx="7569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NN</a:t>
            </a:r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altLang="zh-CN" sz="1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44CAA0FE-D770-498D-B3B2-6F23733D5E4E}"/>
              </a:ext>
            </a:extLst>
          </p:cNvPr>
          <p:cNvSpPr txBox="1"/>
          <p:nvPr/>
        </p:nvSpPr>
        <p:spPr>
          <a:xfrm>
            <a:off x="1734189" y="575228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oderate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9EB84CB2-C23A-4E01-B83F-CD691053FE8A}"/>
              </a:ext>
            </a:extLst>
          </p:cNvPr>
          <p:cNvSpPr txBox="1"/>
          <p:nvPr/>
        </p:nvSpPr>
        <p:spPr>
          <a:xfrm>
            <a:off x="1734188" y="5906718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eak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xmlns="" id="{3BC30645-03F9-40A0-8145-98902726A7FA}"/>
              </a:ext>
            </a:extLst>
          </p:cNvPr>
          <p:cNvSpPr txBox="1"/>
          <p:nvPr/>
        </p:nvSpPr>
        <p:spPr>
          <a:xfrm>
            <a:off x="1734189" y="559784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oderate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8F37CC4A-BFBF-4B41-B389-50DCC5A398D7}"/>
              </a:ext>
            </a:extLst>
          </p:cNvPr>
          <p:cNvSpPr txBox="1"/>
          <p:nvPr/>
        </p:nvSpPr>
        <p:spPr>
          <a:xfrm>
            <a:off x="1548087" y="5280374"/>
            <a:ext cx="8739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ozak strength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xmlns="" id="{37F0E108-A719-4089-8EB5-16DFB5FED050}"/>
              </a:ext>
            </a:extLst>
          </p:cNvPr>
          <p:cNvSpPr txBox="1"/>
          <p:nvPr/>
        </p:nvSpPr>
        <p:spPr>
          <a:xfrm>
            <a:off x="3596260" y="5280374"/>
            <a:ext cx="8739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Kozak strength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xmlns="" id="{EB4E3463-F010-43C7-A450-47D7AAAB7788}"/>
              </a:ext>
            </a:extLst>
          </p:cNvPr>
          <p:cNvSpPr txBox="1"/>
          <p:nvPr/>
        </p:nvSpPr>
        <p:spPr>
          <a:xfrm>
            <a:off x="750088" y="380044"/>
            <a:ext cx="383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xmlns="" id="{2A20F9A7-580A-4D2E-B13B-39B88D6A4AEB}"/>
              </a:ext>
            </a:extLst>
          </p:cNvPr>
          <p:cNvSpPr txBox="1"/>
          <p:nvPr/>
        </p:nvSpPr>
        <p:spPr>
          <a:xfrm>
            <a:off x="750087" y="5195629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CAAEDAB0-B15E-4A7B-BDF0-09115BCF6628}"/>
              </a:ext>
            </a:extLst>
          </p:cNvPr>
          <p:cNvSpPr txBox="1"/>
          <p:nvPr/>
        </p:nvSpPr>
        <p:spPr>
          <a:xfrm>
            <a:off x="1137122" y="2660214"/>
            <a:ext cx="4158614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TGGCGGATTCGGAAGCAGATAAGCCACTGAGAAAAATCTCAGCCGCTTTCAAAAAACTAGCAATCATCGTGAATTCACCGAATCCGGAAGTTCCTGTAACGCAATTCTCTCACGCTTGCTCTCTGGTCTCGCCTCTCTTTGGTTGCCTTGGAATAGCTTTTAAGTTTGCGGAAATGGACTATGTTGCCAAGGTTGATGATCTTGTGAGGGCGTCGAGTTCGATATCGACATTAGTGGTAATGATGGACAAAGATATTGAGGCAGATTGTGTAAGGAAAGCTGGTAGTCATACGAGAAACCTTTTGAGGGTTAAGCGTGGTCTTGACATGGTCAAAGTTCTCTTTGAACAGATCATAGCTTCCGAAGGAGATAACTCCTTGAAGGATCCAGCAACTAAGTCTTATGCTCAAGTGTTTGCTCCCCACCATGGATGGGCTATACGGAAAGCTGTTTCTCTTGGGATGTATGCTCTTCCCACAAGGGCTCACCTACTTAATATGCTCAAAGAGGATGAGGCGGCGGCTAAGATACATATGCAAAGCTATGTCAATTCATCGGCACCATTAATCACGTATCTTGATAATCTATTCCTCTCCAAGCAACTCGGTATTGATTGGTGA</a:t>
            </a:r>
            <a:r>
              <a:rPr lang="en-US" altLang="zh-CN" sz="8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GAGCCTGAAAAAAAGGCATAACTATTGTTACTCTTTAGACAAAATAACCTATGTTCTCACATCAAGCTATGTAATGTCATAACAACAGCGACGAAATACATTGGAATAAATTGAGTATGTCCTTAATCTGTCGTTTTATCTCTTCTTTTAATAAACACAGTTTATCTCATAGTAAGCAGAAGAAGCTTTACACGGGTTGTAGGAACGTATTAAACGGTTTGTTTCAATTTCACTCTCTTTGGTTTTGAAATTCTAGTATAAACCAAAGTAGTTGGTGCTTCAAGTTGTGTTACTTATTCAAC</a:t>
            </a:r>
            <a:endParaRPr lang="zh-CN" altLang="en-US" sz="800" dirty="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xmlns="" id="{D45E76F3-B06C-4C8A-82DA-3211DA69AE98}"/>
              </a:ext>
            </a:extLst>
          </p:cNvPr>
          <p:cNvSpPr/>
          <p:nvPr/>
        </p:nvSpPr>
        <p:spPr>
          <a:xfrm>
            <a:off x="1137121" y="603309"/>
            <a:ext cx="4109379" cy="4530212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xmlns="" id="{65079844-09D5-40B7-8F95-9148C63F7148}"/>
              </a:ext>
            </a:extLst>
          </p:cNvPr>
          <p:cNvCxnSpPr>
            <a:cxnSpLocks/>
          </p:cNvCxnSpPr>
          <p:nvPr/>
        </p:nvCxnSpPr>
        <p:spPr>
          <a:xfrm>
            <a:off x="1203746" y="1939475"/>
            <a:ext cx="91420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xmlns="" id="{D642F33F-BBAC-4185-AA42-BB55C9854FF7}"/>
              </a:ext>
            </a:extLst>
          </p:cNvPr>
          <p:cNvCxnSpPr>
            <a:cxnSpLocks/>
          </p:cNvCxnSpPr>
          <p:nvPr/>
        </p:nvCxnSpPr>
        <p:spPr>
          <a:xfrm>
            <a:off x="1203745" y="2329057"/>
            <a:ext cx="330623" cy="0"/>
          </a:xfrm>
          <a:prstGeom prst="line">
            <a:avLst/>
          </a:prstGeom>
          <a:ln>
            <a:solidFill>
              <a:srgbClr val="2F559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70803768-80AB-4875-A289-09274438B3D4}"/>
              </a:ext>
            </a:extLst>
          </p:cNvPr>
          <p:cNvSpPr txBox="1"/>
          <p:nvPr/>
        </p:nvSpPr>
        <p:spPr>
          <a:xfrm>
            <a:off x="1196928" y="5282248"/>
            <a:ext cx="4138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</a:p>
        </p:txBody>
      </p:sp>
    </p:spTree>
    <p:extLst>
      <p:ext uri="{BB962C8B-B14F-4D97-AF65-F5344CB8AC3E}">
        <p14:creationId xmlns:p14="http://schemas.microsoft.com/office/powerpoint/2010/main" val="34007512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FDCA51E8-73E7-4AC7-BBF4-E64A477D68DF}"/>
              </a:ext>
            </a:extLst>
          </p:cNvPr>
          <p:cNvSpPr/>
          <p:nvPr/>
        </p:nvSpPr>
        <p:spPr>
          <a:xfrm>
            <a:off x="51378" y="164599"/>
            <a:ext cx="6319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>
            <a:extLst>
              <a:ext uri="{FF2B5EF4-FFF2-40B4-BE49-F238E27FC236}">
                <a16:creationId xmlns:a16="http://schemas.microsoft.com/office/drawing/2014/main" xmlns="" id="{11C8696D-2C06-4252-B8EA-0B54EF1560F8}"/>
              </a:ext>
            </a:extLst>
          </p:cNvPr>
          <p:cNvGrpSpPr/>
          <p:nvPr/>
        </p:nvGrpSpPr>
        <p:grpSpPr>
          <a:xfrm>
            <a:off x="810267" y="3521632"/>
            <a:ext cx="4548127" cy="2087353"/>
            <a:chOff x="1632133" y="3183738"/>
            <a:chExt cx="2859301" cy="2087353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xmlns="" id="{55292D9F-25F1-4358-9661-A0D60D4A878A}"/>
                </a:ext>
              </a:extLst>
            </p:cNvPr>
            <p:cNvGrpSpPr/>
            <p:nvPr/>
          </p:nvGrpSpPr>
          <p:grpSpPr>
            <a:xfrm>
              <a:off x="1632133" y="3183738"/>
              <a:ext cx="2859301" cy="2087353"/>
              <a:chOff x="7797092" y="119626"/>
              <a:chExt cx="2859301" cy="2087353"/>
            </a:xfrm>
          </p:grpSpPr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xmlns="" id="{9638194D-A85B-4BE7-B9C6-1412245223F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88245" y="579902"/>
                <a:ext cx="676954" cy="170142"/>
              </a:xfrm>
              <a:prstGeom prst="line">
                <a:avLst/>
              </a:prstGeom>
              <a:ln>
                <a:solidFill>
                  <a:srgbClr val="2F5597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>
                <a:extLst>
                  <a:ext uri="{FF2B5EF4-FFF2-40B4-BE49-F238E27FC236}">
                    <a16:creationId xmlns:a16="http://schemas.microsoft.com/office/drawing/2014/main" xmlns="" id="{EC589B22-ECA8-4AB1-AC75-305CC597EB9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55143" y="576596"/>
                <a:ext cx="1459651" cy="213876"/>
              </a:xfrm>
              <a:prstGeom prst="line">
                <a:avLst/>
              </a:prstGeom>
              <a:ln>
                <a:solidFill>
                  <a:srgbClr val="2F5597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xmlns="" id="{05799C57-DCDA-4ADD-9859-0EEF34A7BC1A}"/>
                  </a:ext>
                </a:extLst>
              </p:cNvPr>
              <p:cNvSpPr txBox="1"/>
              <p:nvPr/>
            </p:nvSpPr>
            <p:spPr>
              <a:xfrm>
                <a:off x="7797092" y="760429"/>
                <a:ext cx="452731" cy="14465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on-0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NF-Che-2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y-1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ar1</a:t>
                </a:r>
              </a:p>
              <a:p>
                <a:pPr algn="r"/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s-2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su-0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t-1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DV-18</a:t>
                </a: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ur-0</a:t>
                </a:r>
              </a:p>
            </p:txBody>
          </p: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xmlns="" id="{43D6FCA0-9E4F-4FA7-8E8D-9ED9D737265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94668" y="386880"/>
                <a:ext cx="2108683" cy="0"/>
              </a:xfrm>
              <a:prstGeom prst="line">
                <a:avLst/>
              </a:prstGeom>
              <a:ln w="9525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xmlns="" id="{546CB065-4752-4BD0-B091-C64BFA554981}"/>
                  </a:ext>
                </a:extLst>
              </p:cNvPr>
              <p:cNvSpPr/>
              <p:nvPr/>
            </p:nvSpPr>
            <p:spPr>
              <a:xfrm>
                <a:off x="9282487" y="304502"/>
                <a:ext cx="998547" cy="144930"/>
              </a:xfrm>
              <a:prstGeom prst="rect">
                <a:avLst/>
              </a:prstGeom>
              <a:solidFill>
                <a:srgbClr val="ED7D31"/>
              </a:solid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ORF</a:t>
                </a:r>
                <a:endParaRPr lang="zh-CN" altLang="en-US" sz="8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xmlns="" id="{DC055CE7-7D51-4F0D-BDCD-DE6C320C8BB6}"/>
                  </a:ext>
                </a:extLst>
              </p:cNvPr>
              <p:cNvSpPr txBox="1"/>
              <p:nvPr/>
            </p:nvSpPr>
            <p:spPr>
              <a:xfrm>
                <a:off x="9141581" y="119626"/>
                <a:ext cx="2249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4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xmlns="" id="{31D2B17F-A6E9-4F1D-B771-885DBFF239C0}"/>
                  </a:ext>
                </a:extLst>
              </p:cNvPr>
              <p:cNvSpPr txBox="1"/>
              <p:nvPr/>
            </p:nvSpPr>
            <p:spPr>
              <a:xfrm>
                <a:off x="10042343" y="120424"/>
                <a:ext cx="2612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6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xmlns="" id="{06FD863C-5A00-4BD8-A0DA-3ED49FC0BD3A}"/>
                  </a:ext>
                </a:extLst>
              </p:cNvPr>
              <p:cNvSpPr txBox="1"/>
              <p:nvPr/>
            </p:nvSpPr>
            <p:spPr>
              <a:xfrm>
                <a:off x="10395179" y="297166"/>
                <a:ext cx="2612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36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xmlns="" id="{5061851C-1913-4044-8E15-24BAACDCED05}"/>
                  </a:ext>
                </a:extLst>
              </p:cNvPr>
              <p:cNvSpPr txBox="1"/>
              <p:nvPr/>
            </p:nvSpPr>
            <p:spPr>
              <a:xfrm>
                <a:off x="8151846" y="251544"/>
                <a:ext cx="15237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5" name="直接连接符 34">
                <a:extLst>
                  <a:ext uri="{FF2B5EF4-FFF2-40B4-BE49-F238E27FC236}">
                    <a16:creationId xmlns:a16="http://schemas.microsoft.com/office/drawing/2014/main" xmlns="" id="{F2D4656B-F149-422D-A8BA-A1232BA4A1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960592" y="391301"/>
                <a:ext cx="0" cy="180000"/>
              </a:xfrm>
              <a:prstGeom prst="line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>
                <a:extLst>
                  <a:ext uri="{FF2B5EF4-FFF2-40B4-BE49-F238E27FC236}">
                    <a16:creationId xmlns:a16="http://schemas.microsoft.com/office/drawing/2014/main" xmlns="" id="{C0C4D079-4FC9-40B4-8734-5F213A4CCB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67781" y="391301"/>
                <a:ext cx="0" cy="180000"/>
              </a:xfrm>
              <a:prstGeom prst="line">
                <a:avLst/>
              </a:prstGeom>
              <a:ln>
                <a:solidFill>
                  <a:schemeClr val="accent1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连接符 36">
                <a:extLst>
                  <a:ext uri="{FF2B5EF4-FFF2-40B4-BE49-F238E27FC236}">
                    <a16:creationId xmlns:a16="http://schemas.microsoft.com/office/drawing/2014/main" xmlns="" id="{8F75080E-13D5-4CA1-AED8-8DD6AF49D03E}"/>
                  </a:ext>
                </a:extLst>
              </p:cNvPr>
              <p:cNvCxnSpPr/>
              <p:nvPr/>
            </p:nvCxnSpPr>
            <p:spPr>
              <a:xfrm>
                <a:off x="8959507" y="579243"/>
                <a:ext cx="112285" cy="0"/>
              </a:xfrm>
              <a:prstGeom prst="line">
                <a:avLst/>
              </a:prstGeom>
              <a:ln>
                <a:solidFill>
                  <a:srgbClr val="2F5597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xmlns="" id="{23FD270C-8C7E-4164-BDC0-59DD44FCA91F}"/>
                  </a:ext>
                </a:extLst>
              </p:cNvPr>
              <p:cNvSpPr txBox="1"/>
              <p:nvPr/>
            </p:nvSpPr>
            <p:spPr>
              <a:xfrm>
                <a:off x="8732507" y="371922"/>
                <a:ext cx="32470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uORF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左中括号 38">
              <a:extLst>
                <a:ext uri="{FF2B5EF4-FFF2-40B4-BE49-F238E27FC236}">
                  <a16:creationId xmlns:a16="http://schemas.microsoft.com/office/drawing/2014/main" xmlns="" id="{A30C79C3-AD22-45C1-8091-AAF9AACFEE10}"/>
                </a:ext>
              </a:extLst>
            </p:cNvPr>
            <p:cNvSpPr/>
            <p:nvPr/>
          </p:nvSpPr>
          <p:spPr>
            <a:xfrm rot="5400000">
              <a:off x="2597708" y="2924189"/>
              <a:ext cx="45719" cy="960767"/>
            </a:xfrm>
            <a:prstGeom prst="lef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xmlns="" id="{BE111314-92DE-4F7D-860B-4ED3A9B24689}"/>
                </a:ext>
              </a:extLst>
            </p:cNvPr>
            <p:cNvSpPr txBox="1"/>
            <p:nvPr/>
          </p:nvSpPr>
          <p:spPr>
            <a:xfrm>
              <a:off x="2354721" y="3205893"/>
              <a:ext cx="3166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5’ UTR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C0C7DE29-7417-4E2F-A6EE-AC4C70EDF40A}"/>
              </a:ext>
            </a:extLst>
          </p:cNvPr>
          <p:cNvSpPr txBox="1"/>
          <p:nvPr/>
        </p:nvSpPr>
        <p:spPr>
          <a:xfrm>
            <a:off x="970241" y="684844"/>
            <a:ext cx="383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53AB3619-0085-459F-BE55-8079083AD7A2}"/>
              </a:ext>
            </a:extLst>
          </p:cNvPr>
          <p:cNvSpPr txBox="1"/>
          <p:nvPr/>
        </p:nvSpPr>
        <p:spPr>
          <a:xfrm>
            <a:off x="970241" y="3180936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xmlns="" id="{6255EEB1-BFCC-4B0D-8542-2F5906090D9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02937397"/>
              </p:ext>
            </p:extLst>
          </p:nvPr>
        </p:nvGraphicFramePr>
        <p:xfrm>
          <a:off x="962658" y="982076"/>
          <a:ext cx="2226099" cy="1978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1" name="图表 40">
            <a:extLst>
              <a:ext uri="{FF2B5EF4-FFF2-40B4-BE49-F238E27FC236}">
                <a16:creationId xmlns:a16="http://schemas.microsoft.com/office/drawing/2014/main" xmlns="" id="{1A501A6B-AB96-4919-BC3A-B76D9FC1EF2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62916766"/>
              </p:ext>
            </p:extLst>
          </p:nvPr>
        </p:nvGraphicFramePr>
        <p:xfrm>
          <a:off x="2088526" y="981593"/>
          <a:ext cx="2786686" cy="1978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椭圆 5">
            <a:extLst>
              <a:ext uri="{FF2B5EF4-FFF2-40B4-BE49-F238E27FC236}">
                <a16:creationId xmlns:a16="http://schemas.microsoft.com/office/drawing/2014/main" xmlns="" id="{4662A41C-AC17-4F83-90E8-637A2505BB0C}"/>
              </a:ext>
            </a:extLst>
          </p:cNvPr>
          <p:cNvSpPr/>
          <p:nvPr/>
        </p:nvSpPr>
        <p:spPr>
          <a:xfrm>
            <a:off x="4471988" y="1400481"/>
            <a:ext cx="855733" cy="1140977"/>
          </a:xfrm>
          <a:prstGeom prst="ellipse">
            <a:avLst/>
          </a:prstGeom>
          <a:solidFill>
            <a:srgbClr val="F4B18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D22F5376-72BD-4BBE-AA3A-14752D60F119}"/>
              </a:ext>
            </a:extLst>
          </p:cNvPr>
          <p:cNvSpPr txBox="1"/>
          <p:nvPr/>
        </p:nvSpPr>
        <p:spPr>
          <a:xfrm>
            <a:off x="4706171" y="1113402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232B13F0-62CB-4B24-BC31-CA82468BC7E6}"/>
              </a:ext>
            </a:extLst>
          </p:cNvPr>
          <p:cNvSpPr txBox="1"/>
          <p:nvPr/>
        </p:nvSpPr>
        <p:spPr>
          <a:xfrm>
            <a:off x="4693213" y="2562241"/>
            <a:ext cx="6543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l-0 typ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9536164E-C47C-4752-89ED-B30212495DAE}"/>
              </a:ext>
            </a:extLst>
          </p:cNvPr>
          <p:cNvSpPr/>
          <p:nvPr/>
        </p:nvSpPr>
        <p:spPr>
          <a:xfrm>
            <a:off x="4693214" y="2649184"/>
            <a:ext cx="34289" cy="45719"/>
          </a:xfrm>
          <a:prstGeom prst="rect">
            <a:avLst/>
          </a:prstGeom>
          <a:solidFill>
            <a:srgbClr val="F4B18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xmlns="" id="{B6780779-8E04-4EAD-B0B9-DC99A4B3EB33}"/>
              </a:ext>
            </a:extLst>
          </p:cNvPr>
          <p:cNvSpPr txBox="1"/>
          <p:nvPr/>
        </p:nvSpPr>
        <p:spPr>
          <a:xfrm>
            <a:off x="4731418" y="1863246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xmlns="" id="{077EA2A3-483D-4EAF-A3CD-D083512B4AB6}"/>
              </a:ext>
            </a:extLst>
          </p:cNvPr>
          <p:cNvSpPr txBox="1"/>
          <p:nvPr/>
        </p:nvSpPr>
        <p:spPr>
          <a:xfrm>
            <a:off x="1744609" y="2052191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96.57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9EF9316D-61D7-479A-90D3-0F17435F4ABB}"/>
              </a:ext>
            </a:extLst>
          </p:cNvPr>
          <p:cNvSpPr txBox="1"/>
          <p:nvPr/>
        </p:nvSpPr>
        <p:spPr>
          <a:xfrm>
            <a:off x="1547874" y="1251273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.43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xmlns="" id="{10656978-E188-4AA1-B2CB-F67FE2FEDF2D}"/>
              </a:ext>
            </a:extLst>
          </p:cNvPr>
          <p:cNvCxnSpPr>
            <a:cxnSpLocks/>
          </p:cNvCxnSpPr>
          <p:nvPr/>
        </p:nvCxnSpPr>
        <p:spPr>
          <a:xfrm>
            <a:off x="1870667" y="1358996"/>
            <a:ext cx="169322" cy="1650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xmlns="" id="{7EDBAC11-0C22-48DF-9748-E040A3ECC4D8}"/>
              </a:ext>
            </a:extLst>
          </p:cNvPr>
          <p:cNvSpPr txBox="1"/>
          <p:nvPr/>
        </p:nvSpPr>
        <p:spPr>
          <a:xfrm>
            <a:off x="3492581" y="1832114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2.96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xmlns="" id="{26489513-1D09-4D5E-9F22-FB1B906A8EF3}"/>
              </a:ext>
            </a:extLst>
          </p:cNvPr>
          <p:cNvSpPr txBox="1"/>
          <p:nvPr/>
        </p:nvSpPr>
        <p:spPr>
          <a:xfrm>
            <a:off x="3075535" y="1869045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6.78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xmlns="" id="{C8E7B1AA-A73B-469B-8D23-A6BF227EF13F}"/>
              </a:ext>
            </a:extLst>
          </p:cNvPr>
          <p:cNvSpPr txBox="1"/>
          <p:nvPr/>
        </p:nvSpPr>
        <p:spPr>
          <a:xfrm>
            <a:off x="2985213" y="1251273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.26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13C5BA67-CED2-4A76-9979-6C61721B1CBA}"/>
              </a:ext>
            </a:extLst>
          </p:cNvPr>
          <p:cNvCxnSpPr>
            <a:cxnSpLocks/>
          </p:cNvCxnSpPr>
          <p:nvPr/>
        </p:nvCxnSpPr>
        <p:spPr>
          <a:xfrm>
            <a:off x="3308006" y="1358996"/>
            <a:ext cx="169322" cy="16500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56">
            <a:extLst>
              <a:ext uri="{FF2B5EF4-FFF2-40B4-BE49-F238E27FC236}">
                <a16:creationId xmlns:a16="http://schemas.microsoft.com/office/drawing/2014/main" xmlns="" id="{862B9878-C20D-44EF-83C6-545DA5988C65}"/>
              </a:ext>
            </a:extLst>
          </p:cNvPr>
          <p:cNvSpPr txBox="1"/>
          <p:nvPr/>
        </p:nvSpPr>
        <p:spPr>
          <a:xfrm>
            <a:off x="1476847" y="4400577"/>
            <a:ext cx="457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ATGAAGGATAGGAATGATCTGAACGCCAAACAAAGACAATTAGTGATCAGCGAATCGCC</a:t>
            </a:r>
            <a:r>
              <a:rPr lang="zh-CN" alt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CCTTTTTGA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xmlns="" id="{7CF5FA62-0370-4F79-8C95-8332AF9FDA4C}"/>
              </a:ext>
            </a:extLst>
          </p:cNvPr>
          <p:cNvSpPr txBox="1"/>
          <p:nvPr/>
        </p:nvSpPr>
        <p:spPr>
          <a:xfrm>
            <a:off x="1476847" y="5139975"/>
            <a:ext cx="4572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ATGAAGGATAGGAATGATCTGAACGCCAAACAAAGACAATTAGTGATCAGCGAATCGCC</a:t>
            </a:r>
            <a:r>
              <a:rPr lang="zh-CN" alt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CCTTTTTGA</a:t>
            </a: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xmlns="" id="{31638B9C-74FC-48B4-8435-7DD5E5976C8E}"/>
              </a:ext>
            </a:extLst>
          </p:cNvPr>
          <p:cNvCxnSpPr>
            <a:cxnSpLocks/>
          </p:cNvCxnSpPr>
          <p:nvPr/>
        </p:nvCxnSpPr>
        <p:spPr>
          <a:xfrm>
            <a:off x="1498490" y="4201186"/>
            <a:ext cx="0" cy="622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xmlns="" id="{8203CCDF-B47B-41C3-BE8D-0EC138F3366E}"/>
              </a:ext>
            </a:extLst>
          </p:cNvPr>
          <p:cNvCxnSpPr>
            <a:cxnSpLocks/>
          </p:cNvCxnSpPr>
          <p:nvPr/>
        </p:nvCxnSpPr>
        <p:spPr>
          <a:xfrm>
            <a:off x="1498490" y="4930449"/>
            <a:ext cx="0" cy="622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F8EE99CA-B171-4061-87FE-4CC3560B157B}"/>
              </a:ext>
            </a:extLst>
          </p:cNvPr>
          <p:cNvSpPr/>
          <p:nvPr/>
        </p:nvSpPr>
        <p:spPr>
          <a:xfrm>
            <a:off x="4564718" y="4436433"/>
            <a:ext cx="167400" cy="87840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xmlns="" id="{1CB2A6B0-B660-44D3-BB51-903E1F499754}"/>
              </a:ext>
            </a:extLst>
          </p:cNvPr>
          <p:cNvSpPr txBox="1"/>
          <p:nvPr/>
        </p:nvSpPr>
        <p:spPr>
          <a:xfrm>
            <a:off x="5224784" y="4400577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2.96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xmlns="" id="{18675177-61BD-406C-B27F-4A96EF63397F}"/>
              </a:ext>
            </a:extLst>
          </p:cNvPr>
          <p:cNvSpPr txBox="1"/>
          <p:nvPr/>
        </p:nvSpPr>
        <p:spPr>
          <a:xfrm>
            <a:off x="5224784" y="5139975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6.78%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xmlns="" id="{6EC0634C-97F3-40D2-98CE-7FE71230866B}"/>
              </a:ext>
            </a:extLst>
          </p:cNvPr>
          <p:cNvSpPr txBox="1"/>
          <p:nvPr/>
        </p:nvSpPr>
        <p:spPr>
          <a:xfrm>
            <a:off x="4551517" y="4239010"/>
            <a:ext cx="2535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zh-CN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79623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xmlns="" id="{9F6C0F4B-585F-4056-87FC-B6A0A768DF8E}"/>
              </a:ext>
            </a:extLst>
          </p:cNvPr>
          <p:cNvCxnSpPr>
            <a:cxnSpLocks/>
          </p:cNvCxnSpPr>
          <p:nvPr/>
        </p:nvCxnSpPr>
        <p:spPr>
          <a:xfrm flipV="1">
            <a:off x="2819718" y="1775938"/>
            <a:ext cx="1847993" cy="400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6E74E541-CD2F-4059-B43C-FDE26F6467C3}"/>
              </a:ext>
            </a:extLst>
          </p:cNvPr>
          <p:cNvSpPr/>
          <p:nvPr/>
        </p:nvSpPr>
        <p:spPr>
          <a:xfrm>
            <a:off x="3331340" y="1700019"/>
            <a:ext cx="467390" cy="153883"/>
          </a:xfrm>
          <a:prstGeom prst="rect">
            <a:avLst/>
          </a:prstGeom>
          <a:solidFill>
            <a:srgbClr val="C8DE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xmlns="" id="{EDC02DFA-0AAF-4625-97F6-1A0F70355054}"/>
              </a:ext>
            </a:extLst>
          </p:cNvPr>
          <p:cNvSpPr/>
          <p:nvPr/>
        </p:nvSpPr>
        <p:spPr>
          <a:xfrm>
            <a:off x="774881" y="787916"/>
            <a:ext cx="6319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ED071060-5C65-4F6E-AEE0-0B3F07E4E4DE}"/>
              </a:ext>
            </a:extLst>
          </p:cNvPr>
          <p:cNvSpPr txBox="1"/>
          <p:nvPr/>
        </p:nvSpPr>
        <p:spPr>
          <a:xfrm>
            <a:off x="2731689" y="2240834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B91FDBA7-4539-4EF5-AC29-4137415A6618}"/>
              </a:ext>
            </a:extLst>
          </p:cNvPr>
          <p:cNvSpPr txBox="1"/>
          <p:nvPr/>
        </p:nvSpPr>
        <p:spPr>
          <a:xfrm>
            <a:off x="2972166" y="22468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B620BF7F-63A4-49BF-BB83-9CA9B2FE2870}"/>
              </a:ext>
            </a:extLst>
          </p:cNvPr>
          <p:cNvSpPr txBox="1"/>
          <p:nvPr/>
        </p:nvSpPr>
        <p:spPr>
          <a:xfrm>
            <a:off x="3127313" y="22468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81EAB066-356D-418F-B149-5152E2E8EC01}"/>
              </a:ext>
            </a:extLst>
          </p:cNvPr>
          <p:cNvSpPr txBox="1"/>
          <p:nvPr/>
        </p:nvSpPr>
        <p:spPr>
          <a:xfrm>
            <a:off x="3285447" y="22468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xmlns="" id="{2BB660E3-8463-4967-954F-415F41E0A9D2}"/>
              </a:ext>
            </a:extLst>
          </p:cNvPr>
          <p:cNvSpPr/>
          <p:nvPr/>
        </p:nvSpPr>
        <p:spPr>
          <a:xfrm>
            <a:off x="3388972" y="1702999"/>
            <a:ext cx="239600" cy="12603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xmlns="" id="{897DD66E-8D9D-4321-9371-53440E707A4D}"/>
              </a:ext>
            </a:extLst>
          </p:cNvPr>
          <p:cNvSpPr/>
          <p:nvPr/>
        </p:nvSpPr>
        <p:spPr>
          <a:xfrm>
            <a:off x="3606793" y="1754219"/>
            <a:ext cx="155999" cy="102663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xmlns="" id="{C351DD55-898B-45F3-BB34-B6CC1438CC30}"/>
              </a:ext>
            </a:extLst>
          </p:cNvPr>
          <p:cNvSpPr/>
          <p:nvPr/>
        </p:nvSpPr>
        <p:spPr>
          <a:xfrm>
            <a:off x="3862007" y="1697890"/>
            <a:ext cx="724148" cy="153882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xmlns="" id="{147DDC12-FBC7-47A4-93CB-8E57C6AD7E12}"/>
              </a:ext>
            </a:extLst>
          </p:cNvPr>
          <p:cNvSpPr/>
          <p:nvPr/>
        </p:nvSpPr>
        <p:spPr>
          <a:xfrm>
            <a:off x="2934065" y="1703000"/>
            <a:ext cx="339787" cy="15388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xmlns="" id="{D312777E-0BD1-470D-BDAD-AD1E1057FB70}"/>
              </a:ext>
            </a:extLst>
          </p:cNvPr>
          <p:cNvSpPr txBox="1"/>
          <p:nvPr/>
        </p:nvSpPr>
        <p:spPr>
          <a:xfrm>
            <a:off x="2949503" y="1668216"/>
            <a:ext cx="42719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pMAS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xmlns="" id="{48D73AF9-5AA8-4676-B1D9-36805945B190}"/>
              </a:ext>
            </a:extLst>
          </p:cNvPr>
          <p:cNvSpPr txBox="1"/>
          <p:nvPr/>
        </p:nvSpPr>
        <p:spPr>
          <a:xfrm>
            <a:off x="3880856" y="1668216"/>
            <a:ext cx="6547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i="1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GFP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6231BD29-B916-4AE6-93C1-D176E1AD7FF3}"/>
              </a:ext>
            </a:extLst>
          </p:cNvPr>
          <p:cNvSpPr txBox="1"/>
          <p:nvPr/>
        </p:nvSpPr>
        <p:spPr>
          <a:xfrm>
            <a:off x="3289424" y="152064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58FC0E66-23BF-4ACB-A9AE-93C49904E3B2}"/>
              </a:ext>
            </a:extLst>
          </p:cNvPr>
          <p:cNvSpPr txBox="1"/>
          <p:nvPr/>
        </p:nvSpPr>
        <p:spPr>
          <a:xfrm>
            <a:off x="3499568" y="1824885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A7498E8D-E885-4EF0-9DF3-4E7B69177086}"/>
              </a:ext>
            </a:extLst>
          </p:cNvPr>
          <p:cNvSpPr txBox="1"/>
          <p:nvPr/>
        </p:nvSpPr>
        <p:spPr>
          <a:xfrm>
            <a:off x="3585529" y="152064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02E67B15-BF96-45F6-ACB6-75BB9333C5DE}"/>
              </a:ext>
            </a:extLst>
          </p:cNvPr>
          <p:cNvSpPr/>
          <p:nvPr/>
        </p:nvSpPr>
        <p:spPr>
          <a:xfrm>
            <a:off x="3661457" y="1702999"/>
            <a:ext cx="42993" cy="12603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xmlns="" id="{356608B5-78D5-4859-B56B-4FCBCDF095C0}"/>
              </a:ext>
            </a:extLst>
          </p:cNvPr>
          <p:cNvSpPr txBox="1"/>
          <p:nvPr/>
        </p:nvSpPr>
        <p:spPr>
          <a:xfrm>
            <a:off x="2862102" y="1346990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xmlns="" id="{2684FAF4-6E58-4C0E-83F1-B4455A04FDD3}"/>
              </a:ext>
            </a:extLst>
          </p:cNvPr>
          <p:cNvSpPr txBox="1"/>
          <p:nvPr/>
        </p:nvSpPr>
        <p:spPr>
          <a:xfrm>
            <a:off x="4084828" y="135764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zh-CN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xmlns="" id="{601B5861-88B4-421E-8199-28D3B25891E8}"/>
              </a:ext>
            </a:extLst>
          </p:cNvPr>
          <p:cNvCxnSpPr/>
          <p:nvPr/>
        </p:nvCxnSpPr>
        <p:spPr>
          <a:xfrm>
            <a:off x="2924908" y="1543384"/>
            <a:ext cx="2057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xmlns="" id="{5495DF56-6DCA-40CC-B530-5699BCA944A1}"/>
              </a:ext>
            </a:extLst>
          </p:cNvPr>
          <p:cNvCxnSpPr>
            <a:cxnSpLocks/>
          </p:cNvCxnSpPr>
          <p:nvPr/>
        </p:nvCxnSpPr>
        <p:spPr>
          <a:xfrm flipH="1">
            <a:off x="4036172" y="1567825"/>
            <a:ext cx="2057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xmlns="" id="{95F97025-64CF-4B83-AF4C-3924FB0F1817}"/>
              </a:ext>
            </a:extLst>
          </p:cNvPr>
          <p:cNvSpPr txBox="1"/>
          <p:nvPr/>
        </p:nvSpPr>
        <p:spPr>
          <a:xfrm>
            <a:off x="3081098" y="1812919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r>
              <a:rPr lang="en-US" altLang="zh-CN" sz="800" baseline="-25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D11</a:t>
            </a:r>
            <a:endParaRPr lang="zh-CN" altLang="en-US" sz="800" baseline="-250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xmlns="" id="{BD4E16EA-DCDF-4E7F-9982-03FC95773C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0832" y="2451918"/>
            <a:ext cx="703991" cy="392065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xmlns="" id="{E66A547F-6341-4384-8F17-786487E71369}"/>
              </a:ext>
            </a:extLst>
          </p:cNvPr>
          <p:cNvSpPr txBox="1"/>
          <p:nvPr/>
        </p:nvSpPr>
        <p:spPr>
          <a:xfrm>
            <a:off x="2357408" y="1111423"/>
            <a:ext cx="383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8E42FFA5-6F45-4367-9856-BE667E83C3D2}"/>
              </a:ext>
            </a:extLst>
          </p:cNvPr>
          <p:cNvSpPr txBox="1"/>
          <p:nvPr/>
        </p:nvSpPr>
        <p:spPr>
          <a:xfrm>
            <a:off x="2357408" y="4768033"/>
            <a:ext cx="341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BD59D5D3-4D08-42DC-B819-1ECEC5201551}"/>
              </a:ext>
            </a:extLst>
          </p:cNvPr>
          <p:cNvSpPr txBox="1"/>
          <p:nvPr/>
        </p:nvSpPr>
        <p:spPr>
          <a:xfrm>
            <a:off x="4088357" y="5284526"/>
            <a:ext cx="894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Confocal microscope</a:t>
            </a:r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xmlns="" id="{D695D67E-4E34-426B-8126-E18D843B4F92}"/>
              </a:ext>
            </a:extLst>
          </p:cNvPr>
          <p:cNvCxnSpPr>
            <a:cxnSpLocks/>
          </p:cNvCxnSpPr>
          <p:nvPr/>
        </p:nvCxnSpPr>
        <p:spPr>
          <a:xfrm flipV="1">
            <a:off x="4430027" y="5204386"/>
            <a:ext cx="0" cy="11421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9CFBE22A-12E3-4F68-B5BF-751BA285464C}"/>
              </a:ext>
            </a:extLst>
          </p:cNvPr>
          <p:cNvSpPr txBox="1"/>
          <p:nvPr/>
        </p:nvSpPr>
        <p:spPr>
          <a:xfrm>
            <a:off x="3888018" y="5009107"/>
            <a:ext cx="2944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2 h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xmlns="" id="{982FBB67-33EE-4C31-88A4-17DF586D14C6}"/>
              </a:ext>
            </a:extLst>
          </p:cNvPr>
          <p:cNvSpPr txBox="1"/>
          <p:nvPr/>
        </p:nvSpPr>
        <p:spPr>
          <a:xfrm>
            <a:off x="2104880" y="5314616"/>
            <a:ext cx="17571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 injection</a:t>
            </a:r>
          </a:p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oaked in 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100 spores/µl Pc zoospores for 0.5 h</a:t>
            </a:r>
          </a:p>
          <a:p>
            <a:pPr algn="r"/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/10 CF injection</a:t>
            </a:r>
          </a:p>
          <a:p>
            <a:pPr algn="r"/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10</a:t>
            </a:r>
            <a:r>
              <a:rPr lang="en-US" altLang="zh-CN" sz="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6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en-US" altLang="zh-CN" sz="800" dirty="0" err="1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fu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/ml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DC3000 </a:t>
            </a:r>
            <a:r>
              <a:rPr lang="en-US" altLang="zh-CN" sz="8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jection</a:t>
            </a:r>
          </a:p>
          <a:p>
            <a:pPr algn="r"/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10</a:t>
            </a:r>
            <a:r>
              <a:rPr lang="en-US" altLang="zh-CN" sz="8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6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en-US" altLang="zh-CN" sz="800" dirty="0" err="1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fu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/ml</a:t>
            </a:r>
            <a:r>
              <a:rPr lang="en-US" altLang="zh-CN" sz="8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vrRPT2 </a:t>
            </a:r>
            <a:r>
              <a:rPr lang="en-US" altLang="zh-CN" sz="8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ection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xmlns="" id="{9D4A4162-5C7C-48B8-AAF9-11B49D086820}"/>
              </a:ext>
            </a:extLst>
          </p:cNvPr>
          <p:cNvCxnSpPr>
            <a:cxnSpLocks/>
          </p:cNvCxnSpPr>
          <p:nvPr/>
        </p:nvCxnSpPr>
        <p:spPr>
          <a:xfrm flipV="1">
            <a:off x="3667525" y="5204386"/>
            <a:ext cx="0" cy="11421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55D0A681-2107-4A83-8D6E-A23A0E7AD986}"/>
              </a:ext>
            </a:extLst>
          </p:cNvPr>
          <p:cNvCxnSpPr>
            <a:cxnSpLocks/>
          </p:cNvCxnSpPr>
          <p:nvPr/>
        </p:nvCxnSpPr>
        <p:spPr>
          <a:xfrm>
            <a:off x="3665068" y="5000397"/>
            <a:ext cx="0" cy="180579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xmlns="" id="{E07B1B5F-1992-441E-A2AB-C07042AD3817}"/>
              </a:ext>
            </a:extLst>
          </p:cNvPr>
          <p:cNvCxnSpPr>
            <a:cxnSpLocks/>
          </p:cNvCxnSpPr>
          <p:nvPr/>
        </p:nvCxnSpPr>
        <p:spPr>
          <a:xfrm>
            <a:off x="4430029" y="5000397"/>
            <a:ext cx="0" cy="180579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xmlns="" id="{60A12966-00FA-4911-B7EA-896CACBEE788}"/>
              </a:ext>
            </a:extLst>
          </p:cNvPr>
          <p:cNvCxnSpPr>
            <a:cxnSpLocks/>
          </p:cNvCxnSpPr>
          <p:nvPr/>
        </p:nvCxnSpPr>
        <p:spPr>
          <a:xfrm flipH="1">
            <a:off x="3657400" y="5101284"/>
            <a:ext cx="1863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xmlns="" id="{135BE374-2684-488C-93E9-017721AA1CF7}"/>
              </a:ext>
            </a:extLst>
          </p:cNvPr>
          <p:cNvCxnSpPr>
            <a:cxnSpLocks/>
          </p:cNvCxnSpPr>
          <p:nvPr/>
        </p:nvCxnSpPr>
        <p:spPr>
          <a:xfrm>
            <a:off x="3452248" y="5004647"/>
            <a:ext cx="134102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xmlns="" id="{57831A42-27E2-4DFC-9438-AB646240F870}"/>
              </a:ext>
            </a:extLst>
          </p:cNvPr>
          <p:cNvSpPr txBox="1"/>
          <p:nvPr/>
        </p:nvSpPr>
        <p:spPr>
          <a:xfrm>
            <a:off x="4436482" y="4729613"/>
            <a:ext cx="5462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xmlns="" id="{65A49628-1EB8-413E-8B8B-C7D2A373F618}"/>
              </a:ext>
            </a:extLst>
          </p:cNvPr>
          <p:cNvSpPr txBox="1"/>
          <p:nvPr/>
        </p:nvSpPr>
        <p:spPr>
          <a:xfrm>
            <a:off x="2573651" y="4865136"/>
            <a:ext cx="7955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A. thaliana</a:t>
            </a:r>
          </a:p>
          <a:p>
            <a:pPr algn="ct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</a:p>
        </p:txBody>
      </p: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xmlns="" id="{D383E777-1276-42D3-8CF8-EF97541EB1F1}"/>
              </a:ext>
            </a:extLst>
          </p:cNvPr>
          <p:cNvCxnSpPr>
            <a:cxnSpLocks/>
          </p:cNvCxnSpPr>
          <p:nvPr/>
        </p:nvCxnSpPr>
        <p:spPr>
          <a:xfrm>
            <a:off x="4249793" y="5104554"/>
            <a:ext cx="1863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xmlns="" id="{26554E55-7C22-482A-BDE1-78F2D19B3805}"/>
              </a:ext>
            </a:extLst>
          </p:cNvPr>
          <p:cNvSpPr txBox="1"/>
          <p:nvPr/>
        </p:nvSpPr>
        <p:spPr>
          <a:xfrm>
            <a:off x="2357408" y="3153490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7" name="组合 146">
            <a:extLst>
              <a:ext uri="{FF2B5EF4-FFF2-40B4-BE49-F238E27FC236}">
                <a16:creationId xmlns:a16="http://schemas.microsoft.com/office/drawing/2014/main" xmlns="" id="{C85B8576-BF73-4778-9F28-15CF80A3B4CC}"/>
              </a:ext>
            </a:extLst>
          </p:cNvPr>
          <p:cNvGrpSpPr/>
          <p:nvPr/>
        </p:nvGrpSpPr>
        <p:grpSpPr>
          <a:xfrm>
            <a:off x="2860833" y="3375445"/>
            <a:ext cx="1842554" cy="964276"/>
            <a:chOff x="3899878" y="3027101"/>
            <a:chExt cx="4057077" cy="1592413"/>
          </a:xfrm>
        </p:grpSpPr>
        <p:pic>
          <p:nvPicPr>
            <p:cNvPr id="144" name="图片 143">
              <a:extLst>
                <a:ext uri="{FF2B5EF4-FFF2-40B4-BE49-F238E27FC236}">
                  <a16:creationId xmlns:a16="http://schemas.microsoft.com/office/drawing/2014/main" xmlns="" id="{F49C064E-4C6A-45D5-90B2-5FE2DD4C1C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214" t="44460" r="43378" b="32320"/>
            <a:stretch/>
          </p:blipFill>
          <p:spPr>
            <a:xfrm>
              <a:off x="5971953" y="3027103"/>
              <a:ext cx="1985002" cy="1592411"/>
            </a:xfrm>
            <a:prstGeom prst="rect">
              <a:avLst/>
            </a:prstGeom>
          </p:spPr>
        </p:pic>
        <p:pic>
          <p:nvPicPr>
            <p:cNvPr id="146" name="图片 145">
              <a:extLst>
                <a:ext uri="{FF2B5EF4-FFF2-40B4-BE49-F238E27FC236}">
                  <a16:creationId xmlns:a16="http://schemas.microsoft.com/office/drawing/2014/main" xmlns="" id="{F4C547E4-ADCB-4288-8584-04D675156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55" t="45440" r="43497" b="31340"/>
            <a:stretch/>
          </p:blipFill>
          <p:spPr>
            <a:xfrm>
              <a:off x="3899878" y="3027101"/>
              <a:ext cx="1985001" cy="1592413"/>
            </a:xfrm>
            <a:prstGeom prst="rect">
              <a:avLst/>
            </a:prstGeom>
          </p:spPr>
        </p:pic>
      </p:grpSp>
      <p:sp>
        <p:nvSpPr>
          <p:cNvPr id="148" name="文本框 147">
            <a:extLst>
              <a:ext uri="{FF2B5EF4-FFF2-40B4-BE49-F238E27FC236}">
                <a16:creationId xmlns:a16="http://schemas.microsoft.com/office/drawing/2014/main" xmlns="" id="{ABE3F172-0EFA-4DD5-8E62-763DFE6EF7FA}"/>
              </a:ext>
            </a:extLst>
          </p:cNvPr>
          <p:cNvSpPr txBox="1"/>
          <p:nvPr/>
        </p:nvSpPr>
        <p:spPr>
          <a:xfrm>
            <a:off x="2858969" y="3160001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xmlns="" id="{FA0E7B1B-E506-4EB2-86FA-8C2CB44B7D28}"/>
              </a:ext>
            </a:extLst>
          </p:cNvPr>
          <p:cNvSpPr txBox="1"/>
          <p:nvPr/>
        </p:nvSpPr>
        <p:spPr>
          <a:xfrm>
            <a:off x="3213947" y="3158684"/>
            <a:ext cx="6351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AT-GF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xmlns="" id="{2D80A5D0-D39D-4AB3-BAE1-40FE9936BA92}"/>
              </a:ext>
            </a:extLst>
          </p:cNvPr>
          <p:cNvSpPr txBox="1"/>
          <p:nvPr/>
        </p:nvSpPr>
        <p:spPr>
          <a:xfrm>
            <a:off x="3821570" y="3155543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xmlns="" id="{6F857F65-B2DD-4E49-8DFE-2AF46E99EF69}"/>
              </a:ext>
            </a:extLst>
          </p:cNvPr>
          <p:cNvSpPr txBox="1"/>
          <p:nvPr/>
        </p:nvSpPr>
        <p:spPr>
          <a:xfrm>
            <a:off x="4135941" y="3148297"/>
            <a:ext cx="6351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NAT-GF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xmlns="" id="{388FB42A-4C67-4016-8600-B1AFE9A3400C}"/>
              </a:ext>
            </a:extLst>
          </p:cNvPr>
          <p:cNvSpPr txBox="1"/>
          <p:nvPr/>
        </p:nvSpPr>
        <p:spPr>
          <a:xfrm>
            <a:off x="2895018" y="4324440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right field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xmlns="" id="{B4CDDE2C-C6C3-4045-AA47-E58524826B7E}"/>
              </a:ext>
            </a:extLst>
          </p:cNvPr>
          <p:cNvSpPr txBox="1"/>
          <p:nvPr/>
        </p:nvSpPr>
        <p:spPr>
          <a:xfrm>
            <a:off x="4040002" y="4324440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31633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899D362E-9495-4FFE-849D-927BC5F9EBA4}"/>
              </a:ext>
            </a:extLst>
          </p:cNvPr>
          <p:cNvSpPr/>
          <p:nvPr/>
        </p:nvSpPr>
        <p:spPr>
          <a:xfrm>
            <a:off x="1369038" y="1489965"/>
            <a:ext cx="6319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xmlns="" id="{624FB66F-E9F1-4865-940B-75965C822665}"/>
              </a:ext>
            </a:extLst>
          </p:cNvPr>
          <p:cNvCxnSpPr>
            <a:cxnSpLocks/>
          </p:cNvCxnSpPr>
          <p:nvPr/>
        </p:nvCxnSpPr>
        <p:spPr>
          <a:xfrm flipV="1">
            <a:off x="2826862" y="2556988"/>
            <a:ext cx="1847993" cy="400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矩形 43">
            <a:extLst>
              <a:ext uri="{FF2B5EF4-FFF2-40B4-BE49-F238E27FC236}">
                <a16:creationId xmlns:a16="http://schemas.microsoft.com/office/drawing/2014/main" xmlns="" id="{1B57625E-05D0-4577-AC01-D8E13BEEA704}"/>
              </a:ext>
            </a:extLst>
          </p:cNvPr>
          <p:cNvSpPr/>
          <p:nvPr/>
        </p:nvSpPr>
        <p:spPr>
          <a:xfrm>
            <a:off x="3338484" y="2481069"/>
            <a:ext cx="467390" cy="153883"/>
          </a:xfrm>
          <a:prstGeom prst="rect">
            <a:avLst/>
          </a:prstGeom>
          <a:solidFill>
            <a:srgbClr val="C8DE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304D50D9-E8D8-43FF-906A-71DC33B79C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952" t="76789" r="29738" b="14135"/>
          <a:stretch/>
        </p:blipFill>
        <p:spPr>
          <a:xfrm>
            <a:off x="2869246" y="3599916"/>
            <a:ext cx="1782096" cy="518593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xmlns="" id="{F4D66C17-BD77-4C0A-8654-05C2B13C4E55}"/>
              </a:ext>
            </a:extLst>
          </p:cNvPr>
          <p:cNvSpPr txBox="1"/>
          <p:nvPr/>
        </p:nvSpPr>
        <p:spPr>
          <a:xfrm>
            <a:off x="2758932" y="3380348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xmlns="" id="{9632B97E-1371-4DBC-8B5F-5D2FF379D9CC}"/>
              </a:ext>
            </a:extLst>
          </p:cNvPr>
          <p:cNvSpPr/>
          <p:nvPr/>
        </p:nvSpPr>
        <p:spPr>
          <a:xfrm rot="20579671">
            <a:off x="3005424" y="3016317"/>
            <a:ext cx="13644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pPR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::orf1-2-LECRK-VI.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xmlns="" id="{BDFF77BC-2025-47B6-B49C-EAEB1348DECA}"/>
              </a:ext>
            </a:extLst>
          </p:cNvPr>
          <p:cNvSpPr/>
          <p:nvPr/>
        </p:nvSpPr>
        <p:spPr>
          <a:xfrm rot="20579671">
            <a:off x="3573664" y="3032491"/>
            <a:ext cx="125386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pPR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::WT-LECRK-VI.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xmlns="" id="{D7E9CBA9-B96A-400F-99AD-C038C4E0492A}"/>
              </a:ext>
            </a:extLst>
          </p:cNvPr>
          <p:cNvSpPr/>
          <p:nvPr/>
        </p:nvSpPr>
        <p:spPr>
          <a:xfrm rot="20579671">
            <a:off x="4025273" y="3002955"/>
            <a:ext cx="145584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pPR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::orf1-2-3-LECRK-VI.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xmlns="" id="{3AB1B6F1-321A-4134-96B4-607DBDB3E67C}"/>
              </a:ext>
            </a:extLst>
          </p:cNvPr>
          <p:cNvCxnSpPr>
            <a:cxnSpLocks/>
          </p:cNvCxnSpPr>
          <p:nvPr/>
        </p:nvCxnSpPr>
        <p:spPr>
          <a:xfrm>
            <a:off x="3126769" y="3373517"/>
            <a:ext cx="43782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xmlns="" id="{47AF2D31-BA11-4657-97B7-3944B2934FD2}"/>
              </a:ext>
            </a:extLst>
          </p:cNvPr>
          <p:cNvCxnSpPr>
            <a:cxnSpLocks/>
          </p:cNvCxnSpPr>
          <p:nvPr/>
        </p:nvCxnSpPr>
        <p:spPr>
          <a:xfrm>
            <a:off x="3641119" y="3373517"/>
            <a:ext cx="43782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xmlns="" id="{83F04BE3-EAF7-474C-9102-C3DBBC589889}"/>
              </a:ext>
            </a:extLst>
          </p:cNvPr>
          <p:cNvCxnSpPr>
            <a:cxnSpLocks/>
          </p:cNvCxnSpPr>
          <p:nvPr/>
        </p:nvCxnSpPr>
        <p:spPr>
          <a:xfrm>
            <a:off x="4155469" y="3373517"/>
            <a:ext cx="437829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xmlns="" id="{589CB808-3CC1-42E9-BE60-C6D1F50E0634}"/>
              </a:ext>
            </a:extLst>
          </p:cNvPr>
          <p:cNvSpPr txBox="1"/>
          <p:nvPr/>
        </p:nvSpPr>
        <p:spPr>
          <a:xfrm>
            <a:off x="3000016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xmlns="" id="{46F3DAE6-E9AE-43C3-BBFC-F82AD6D8FFA5}"/>
              </a:ext>
            </a:extLst>
          </p:cNvPr>
          <p:cNvSpPr txBox="1"/>
          <p:nvPr/>
        </p:nvSpPr>
        <p:spPr>
          <a:xfrm>
            <a:off x="3155163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xmlns="" id="{CE9936AA-09D0-480E-AF6B-5136BADB0ADE}"/>
              </a:ext>
            </a:extLst>
          </p:cNvPr>
          <p:cNvSpPr txBox="1"/>
          <p:nvPr/>
        </p:nvSpPr>
        <p:spPr>
          <a:xfrm>
            <a:off x="3313297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7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xmlns="" id="{BA145C42-B72E-4B61-91B0-97CC6CBBD5A8}"/>
              </a:ext>
            </a:extLst>
          </p:cNvPr>
          <p:cNvSpPr txBox="1"/>
          <p:nvPr/>
        </p:nvSpPr>
        <p:spPr>
          <a:xfrm>
            <a:off x="3514580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xmlns="" id="{B2C7DA82-B44F-4EEA-A9CC-D9A42D37AA98}"/>
              </a:ext>
            </a:extLst>
          </p:cNvPr>
          <p:cNvSpPr txBox="1"/>
          <p:nvPr/>
        </p:nvSpPr>
        <p:spPr>
          <a:xfrm>
            <a:off x="3676871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3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xmlns="" id="{7B642223-4E98-4730-A76F-3837CFC9B10C}"/>
              </a:ext>
            </a:extLst>
          </p:cNvPr>
          <p:cNvSpPr txBox="1"/>
          <p:nvPr/>
        </p:nvSpPr>
        <p:spPr>
          <a:xfrm>
            <a:off x="3842149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xmlns="" id="{F59A86BF-65AB-4966-B6FA-558283FE7852}"/>
              </a:ext>
            </a:extLst>
          </p:cNvPr>
          <p:cNvSpPr txBox="1"/>
          <p:nvPr/>
        </p:nvSpPr>
        <p:spPr>
          <a:xfrm>
            <a:off x="4029941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xmlns="" id="{9C633FF0-4AA9-4759-8B6E-2779ABFDC9E7}"/>
              </a:ext>
            </a:extLst>
          </p:cNvPr>
          <p:cNvSpPr txBox="1"/>
          <p:nvPr/>
        </p:nvSpPr>
        <p:spPr>
          <a:xfrm>
            <a:off x="4192232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4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xmlns="" id="{744E4265-88B2-444D-9183-59D78EF57F1F}"/>
              </a:ext>
            </a:extLst>
          </p:cNvPr>
          <p:cNvSpPr txBox="1"/>
          <p:nvPr/>
        </p:nvSpPr>
        <p:spPr>
          <a:xfrm>
            <a:off x="4357510" y="3390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8#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xmlns="" id="{6139E187-F25B-41C8-AEBA-D3BB38D3339D}"/>
              </a:ext>
            </a:extLst>
          </p:cNvPr>
          <p:cNvSpPr/>
          <p:nvPr/>
        </p:nvSpPr>
        <p:spPr>
          <a:xfrm>
            <a:off x="3396115" y="2484049"/>
            <a:ext cx="239600" cy="12603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xmlns="" id="{3693352E-431D-4A67-9476-1D1ACD80DA37}"/>
              </a:ext>
            </a:extLst>
          </p:cNvPr>
          <p:cNvSpPr/>
          <p:nvPr/>
        </p:nvSpPr>
        <p:spPr>
          <a:xfrm>
            <a:off x="3613936" y="2535270"/>
            <a:ext cx="155999" cy="102663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矩形 66">
            <a:extLst>
              <a:ext uri="{FF2B5EF4-FFF2-40B4-BE49-F238E27FC236}">
                <a16:creationId xmlns:a16="http://schemas.microsoft.com/office/drawing/2014/main" xmlns="" id="{4E56C26E-4E39-4BC8-ABD0-74738A57AF63}"/>
              </a:ext>
            </a:extLst>
          </p:cNvPr>
          <p:cNvSpPr/>
          <p:nvPr/>
        </p:nvSpPr>
        <p:spPr>
          <a:xfrm>
            <a:off x="3869151" y="2488457"/>
            <a:ext cx="724148" cy="126035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xmlns="" id="{5D7A16C8-F9B5-469A-ACD6-E1EE96706921}"/>
              </a:ext>
            </a:extLst>
          </p:cNvPr>
          <p:cNvSpPr/>
          <p:nvPr/>
        </p:nvSpPr>
        <p:spPr>
          <a:xfrm>
            <a:off x="2941209" y="2484050"/>
            <a:ext cx="339787" cy="153883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xmlns="" id="{4F54DB21-D78C-4C41-A185-5CE655E59298}"/>
              </a:ext>
            </a:extLst>
          </p:cNvPr>
          <p:cNvSpPr txBox="1"/>
          <p:nvPr/>
        </p:nvSpPr>
        <p:spPr>
          <a:xfrm>
            <a:off x="2956647" y="2449266"/>
            <a:ext cx="42719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pPR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xmlns="" id="{349019F2-76A6-4281-96B8-CE2925669936}"/>
              </a:ext>
            </a:extLst>
          </p:cNvPr>
          <p:cNvSpPr txBox="1"/>
          <p:nvPr/>
        </p:nvSpPr>
        <p:spPr>
          <a:xfrm>
            <a:off x="3962918" y="2449266"/>
            <a:ext cx="654786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LecRK-VI.2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xmlns="" id="{5F0F4C63-723C-4660-AAD7-59AEA4EB0ACE}"/>
              </a:ext>
            </a:extLst>
          </p:cNvPr>
          <p:cNvSpPr txBox="1"/>
          <p:nvPr/>
        </p:nvSpPr>
        <p:spPr>
          <a:xfrm>
            <a:off x="3296568" y="230169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1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xmlns="" id="{BC933A4C-6973-4F02-B239-656C7A7834D9}"/>
              </a:ext>
            </a:extLst>
          </p:cNvPr>
          <p:cNvSpPr txBox="1"/>
          <p:nvPr/>
        </p:nvSpPr>
        <p:spPr>
          <a:xfrm>
            <a:off x="3506712" y="2605935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2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xmlns="" id="{A98CE0C9-88DE-4638-BF9A-889997989BB8}"/>
              </a:ext>
            </a:extLst>
          </p:cNvPr>
          <p:cNvSpPr txBox="1"/>
          <p:nvPr/>
        </p:nvSpPr>
        <p:spPr>
          <a:xfrm>
            <a:off x="3592673" y="230169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uORF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xmlns="" id="{F90A2D82-8FF5-4C45-A6F9-4261A4F149A7}"/>
              </a:ext>
            </a:extLst>
          </p:cNvPr>
          <p:cNvSpPr/>
          <p:nvPr/>
        </p:nvSpPr>
        <p:spPr>
          <a:xfrm>
            <a:off x="3668601" y="2484049"/>
            <a:ext cx="42993" cy="12603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xmlns="" id="{FA0C38F1-C6D0-49D8-A97C-C20E4A6053E1}"/>
              </a:ext>
            </a:extLst>
          </p:cNvPr>
          <p:cNvSpPr txBox="1"/>
          <p:nvPr/>
        </p:nvSpPr>
        <p:spPr>
          <a:xfrm>
            <a:off x="2869246" y="2128040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xmlns="" id="{3035576D-BF5E-45EF-A0A3-E207434BBC88}"/>
              </a:ext>
            </a:extLst>
          </p:cNvPr>
          <p:cNvSpPr txBox="1"/>
          <p:nvPr/>
        </p:nvSpPr>
        <p:spPr>
          <a:xfrm>
            <a:off x="4091972" y="2138693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zh-CN" alt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接箭头连接符 76">
            <a:extLst>
              <a:ext uri="{FF2B5EF4-FFF2-40B4-BE49-F238E27FC236}">
                <a16:creationId xmlns:a16="http://schemas.microsoft.com/office/drawing/2014/main" xmlns="" id="{874B0F14-FACF-4725-8A56-6D22907EE7A7}"/>
              </a:ext>
            </a:extLst>
          </p:cNvPr>
          <p:cNvCxnSpPr/>
          <p:nvPr/>
        </p:nvCxnSpPr>
        <p:spPr>
          <a:xfrm>
            <a:off x="2932052" y="2324434"/>
            <a:ext cx="2057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xmlns="" id="{0F07B721-000B-4FCD-81A5-B80AE981F53C}"/>
              </a:ext>
            </a:extLst>
          </p:cNvPr>
          <p:cNvCxnSpPr>
            <a:cxnSpLocks/>
          </p:cNvCxnSpPr>
          <p:nvPr/>
        </p:nvCxnSpPr>
        <p:spPr>
          <a:xfrm flipH="1">
            <a:off x="4043316" y="2348875"/>
            <a:ext cx="2057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xmlns="" id="{56331AB9-920D-4E33-9536-045BE3BD5746}"/>
              </a:ext>
            </a:extLst>
          </p:cNvPr>
          <p:cNvSpPr txBox="1"/>
          <p:nvPr/>
        </p:nvSpPr>
        <p:spPr>
          <a:xfrm>
            <a:off x="3088242" y="2593969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  <a:r>
              <a:rPr lang="en-US" altLang="zh-CN" sz="800" baseline="-25000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D11</a:t>
            </a:r>
            <a:endParaRPr lang="zh-CN" altLang="en-US" sz="800" baseline="-25000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370559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15840,&quot;width&quot;:15840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3</Words>
  <Application>Microsoft Office PowerPoint</Application>
  <PresentationFormat>全屏显示(4:3)</PresentationFormat>
  <Paragraphs>131</Paragraphs>
  <Slides>5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</cp:revision>
  <dcterms:created xsi:type="dcterms:W3CDTF">2022-01-11T04:31:17Z</dcterms:created>
  <dcterms:modified xsi:type="dcterms:W3CDTF">2022-01-11T04:31:52Z</dcterms:modified>
</cp:coreProperties>
</file>